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1080135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092" autoAdjust="0"/>
    <p:restoredTop sz="94660"/>
  </p:normalViewPr>
  <p:slideViewPr>
    <p:cSldViewPr>
      <p:cViewPr>
        <p:scale>
          <a:sx n="66" d="100"/>
          <a:sy n="66" d="100"/>
        </p:scale>
        <p:origin x="2366" y="-38"/>
      </p:cViewPr>
      <p:guideLst>
        <p:guide orient="horz" pos="340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F3DF7D-35A5-4E24-9AFC-89C10BF77A18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824038" y="744538"/>
            <a:ext cx="31496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B1E1B0-A4E1-402C-8366-0CAB2C6EC7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439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3355420"/>
            <a:ext cx="7772400" cy="231528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060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791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680086"/>
            <a:ext cx="2057400" cy="14516814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680086"/>
            <a:ext cx="6019800" cy="14516814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152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128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4578074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534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3970497"/>
            <a:ext cx="4038600" cy="112264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3970497"/>
            <a:ext cx="4038600" cy="112264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432555"/>
            <a:ext cx="8229600" cy="1800225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417803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3425428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2417803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3425428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618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006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45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430054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430055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2260283"/>
            <a:ext cx="3008313" cy="73884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8606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458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432555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520316"/>
            <a:ext cx="8229600" cy="71283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10011252"/>
            <a:ext cx="2133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F47C4-5FE9-4337-87CA-5398C32E9BB9}" type="datetimeFigureOut">
              <a:rPr kumimoji="1" lang="ja-JP" altLang="en-US" smtClean="0"/>
              <a:t>2024/9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10011252"/>
            <a:ext cx="2895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10011252"/>
            <a:ext cx="2133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9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D47D27A-378B-2126-2D4A-18C08D27EB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8815" y="498994"/>
            <a:ext cx="5858686" cy="418353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8FA3FE5-173E-CD85-A405-FB10CB4C6866}"/>
              </a:ext>
            </a:extLst>
          </p:cNvPr>
          <p:cNvSpPr txBox="1"/>
          <p:nvPr/>
        </p:nvSpPr>
        <p:spPr>
          <a:xfrm>
            <a:off x="1691680" y="4680595"/>
            <a:ext cx="612068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Mean changes in global health status/QoL</a:t>
            </a:r>
          </a:p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uring pembrolizumab therapy for advanced urothelial carcinoma: Comparison according to the objective response.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expressed as means ± standard deviations. A higher score indicates a higher quality of life. Dashed lines indicate the minimally important difference (MIC) for each scale. Global health status/QoL was assessed using the European Organization for Research and Treatment of Cancer Quality of Life Questionnaire-Core 30. Mann–Whitney U test is applied to compare the data at each time point.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fferenc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etween two groups in any time point.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9548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7</TotalTime>
  <Words>110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User</dc:creator>
  <cp:lastModifiedBy>Makito Miyake</cp:lastModifiedBy>
  <cp:revision>103</cp:revision>
  <cp:lastPrinted>2023-04-27T03:17:31Z</cp:lastPrinted>
  <dcterms:created xsi:type="dcterms:W3CDTF">2022-07-14T15:14:45Z</dcterms:created>
  <dcterms:modified xsi:type="dcterms:W3CDTF">2024-09-11T14:05:35Z</dcterms:modified>
</cp:coreProperties>
</file>